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2" autoAdjust="0"/>
    <p:restoredTop sz="94660"/>
  </p:normalViewPr>
  <p:slideViewPr>
    <p:cSldViewPr snapToGrid="0">
      <p:cViewPr varScale="1">
        <p:scale>
          <a:sx n="61" d="100"/>
          <a:sy n="61" d="100"/>
        </p:scale>
        <p:origin x="215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315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692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44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771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62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838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574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614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904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287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675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45EC91-C11C-4BCD-A5F4-C8430B329A37}" type="datetimeFigureOut">
              <a:rPr lang="en-US" smtClean="0"/>
              <a:t>8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352DB-09B4-47DA-9863-8694E5E984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00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5066" y="79439"/>
            <a:ext cx="6920924" cy="8926939"/>
            <a:chOff x="75066" y="79439"/>
            <a:chExt cx="6920924" cy="8926939"/>
          </a:xfrm>
        </p:grpSpPr>
        <p:grpSp>
          <p:nvGrpSpPr>
            <p:cNvPr id="84" name="Group 83"/>
            <p:cNvGrpSpPr/>
            <p:nvPr/>
          </p:nvGrpSpPr>
          <p:grpSpPr>
            <a:xfrm>
              <a:off x="111726" y="356438"/>
              <a:ext cx="6620049" cy="6120433"/>
              <a:chOff x="120543" y="366834"/>
              <a:chExt cx="6620049" cy="6120433"/>
            </a:xfrm>
          </p:grpSpPr>
          <p:grpSp>
            <p:nvGrpSpPr>
              <p:cNvPr id="85" name="Group 84"/>
              <p:cNvGrpSpPr/>
              <p:nvPr/>
            </p:nvGrpSpPr>
            <p:grpSpPr>
              <a:xfrm>
                <a:off x="268179" y="437223"/>
                <a:ext cx="6472413" cy="6050044"/>
                <a:chOff x="228600" y="990600"/>
                <a:chExt cx="6472413" cy="6050044"/>
              </a:xfrm>
            </p:grpSpPr>
            <p:grpSp>
              <p:nvGrpSpPr>
                <p:cNvPr id="91" name="Group 90"/>
                <p:cNvGrpSpPr/>
                <p:nvPr/>
              </p:nvGrpSpPr>
              <p:grpSpPr>
                <a:xfrm>
                  <a:off x="461451" y="1953935"/>
                  <a:ext cx="6013282" cy="1424396"/>
                  <a:chOff x="446225" y="1676400"/>
                  <a:chExt cx="6013282" cy="1424396"/>
                </a:xfrm>
              </p:grpSpPr>
              <p:grpSp>
                <p:nvGrpSpPr>
                  <p:cNvPr id="154" name="Group 153"/>
                  <p:cNvGrpSpPr/>
                  <p:nvPr/>
                </p:nvGrpSpPr>
                <p:grpSpPr>
                  <a:xfrm>
                    <a:off x="446225" y="1676400"/>
                    <a:ext cx="6013282" cy="1093842"/>
                    <a:chOff x="446225" y="1676400"/>
                    <a:chExt cx="6013282" cy="1093842"/>
                  </a:xfrm>
                </p:grpSpPr>
                <p:sp>
                  <p:nvSpPr>
                    <p:cNvPr id="157" name="TextBox 156"/>
                    <p:cNvSpPr txBox="1"/>
                    <p:nvPr/>
                  </p:nvSpPr>
                  <p:spPr>
                    <a:xfrm>
                      <a:off x="603939" y="1676400"/>
                      <a:ext cx="4443204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 Vector for Knock-In of </a:t>
                      </a:r>
                      <a:r>
                        <a:rPr lang="en-US" sz="12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t6</a:t>
                      </a:r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LAG in ROSA26 Locus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58" name="Group 157"/>
                    <p:cNvGrpSpPr/>
                    <p:nvPr/>
                  </p:nvGrpSpPr>
                  <p:grpSpPr>
                    <a:xfrm>
                      <a:off x="446225" y="2068730"/>
                      <a:ext cx="6013282" cy="701512"/>
                      <a:chOff x="463718" y="1626970"/>
                      <a:chExt cx="6013282" cy="701512"/>
                    </a:xfrm>
                  </p:grpSpPr>
                  <p:cxnSp>
                    <p:nvCxnSpPr>
                      <p:cNvPr id="159" name="Straight Connector 158"/>
                      <p:cNvCxnSpPr/>
                      <p:nvPr/>
                    </p:nvCxnSpPr>
                    <p:spPr>
                      <a:xfrm>
                        <a:off x="463718" y="1905000"/>
                        <a:ext cx="914400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0070C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0" name="Straight Connector 159"/>
                      <p:cNvCxnSpPr/>
                      <p:nvPr/>
                    </p:nvCxnSpPr>
                    <p:spPr>
                      <a:xfrm>
                        <a:off x="4038600" y="1907628"/>
                        <a:ext cx="2438400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FF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61" name="Rectangle 160"/>
                      <p:cNvSpPr/>
                      <p:nvPr/>
                    </p:nvSpPr>
                    <p:spPr>
                      <a:xfrm>
                        <a:off x="1378118" y="1633210"/>
                        <a:ext cx="2965282" cy="424190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cxnSp>
                    <p:nvCxnSpPr>
                      <p:cNvPr id="162" name="Straight Connector 161"/>
                      <p:cNvCxnSpPr/>
                      <p:nvPr/>
                    </p:nvCxnSpPr>
                    <p:spPr>
                      <a:xfrm>
                        <a:off x="3324557" y="1646345"/>
                        <a:ext cx="0" cy="42419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63" name="Isosceles Triangle 162"/>
                      <p:cNvSpPr/>
                      <p:nvPr/>
                    </p:nvSpPr>
                    <p:spPr>
                      <a:xfrm rot="16200000">
                        <a:off x="3177047" y="1890422"/>
                        <a:ext cx="152401" cy="141554"/>
                      </a:xfrm>
                      <a:prstGeom prst="triangle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64" name="Isosceles Triangle 163"/>
                      <p:cNvSpPr/>
                      <p:nvPr/>
                    </p:nvSpPr>
                    <p:spPr>
                      <a:xfrm rot="16200000">
                        <a:off x="1503903" y="1654030"/>
                        <a:ext cx="152401" cy="141554"/>
                      </a:xfrm>
                      <a:prstGeom prst="triangle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65" name="TextBox 164"/>
                      <p:cNvSpPr txBox="1"/>
                      <p:nvPr/>
                    </p:nvSpPr>
                    <p:spPr>
                      <a:xfrm>
                        <a:off x="1600200" y="1735030"/>
                        <a:ext cx="1693541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eo-STOP2xSV40pA</a:t>
                        </a:r>
                        <a:endPara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66" name="TextBox 165"/>
                      <p:cNvSpPr txBox="1"/>
                      <p:nvPr/>
                    </p:nvSpPr>
                    <p:spPr>
                      <a:xfrm>
                        <a:off x="3228076" y="1648607"/>
                        <a:ext cx="997389" cy="46166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1200" b="1" i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irt6</a:t>
                        </a:r>
                        <a:r>
                          <a:rPr lang="en-US" sz="12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FLAG</a:t>
                        </a:r>
                      </a:p>
                      <a:p>
                        <a:pPr algn="ctr"/>
                        <a:r>
                          <a:rPr lang="en-US" sz="12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DNA</a:t>
                        </a:r>
                        <a:endPara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167" name="Straight Connector 166"/>
                      <p:cNvCxnSpPr/>
                      <p:nvPr/>
                    </p:nvCxnSpPr>
                    <p:spPr>
                      <a:xfrm>
                        <a:off x="1493868" y="1627293"/>
                        <a:ext cx="0" cy="42419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8" name="Straight Connector 167"/>
                      <p:cNvCxnSpPr/>
                      <p:nvPr/>
                    </p:nvCxnSpPr>
                    <p:spPr>
                      <a:xfrm>
                        <a:off x="4144751" y="1626970"/>
                        <a:ext cx="0" cy="42419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69" name="TextBox 168"/>
                      <p:cNvSpPr txBox="1"/>
                      <p:nvPr/>
                    </p:nvSpPr>
                    <p:spPr>
                      <a:xfrm>
                        <a:off x="4053134" y="2051483"/>
                        <a:ext cx="73129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GHpA</a:t>
                        </a:r>
                        <a:endPara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70" name="TextBox 169"/>
                      <p:cNvSpPr txBox="1"/>
                      <p:nvPr/>
                    </p:nvSpPr>
                    <p:spPr>
                      <a:xfrm>
                        <a:off x="761164" y="1643390"/>
                        <a:ext cx="397866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A</a:t>
                        </a:r>
                        <a:endPara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71" name="TextBox 170"/>
                      <p:cNvSpPr txBox="1"/>
                      <p:nvPr/>
                    </p:nvSpPr>
                    <p:spPr>
                      <a:xfrm>
                        <a:off x="5066882" y="1643390"/>
                        <a:ext cx="389850" cy="27699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2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A</a:t>
                        </a:r>
                        <a:endPara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sp>
                <p:nvSpPr>
                  <p:cNvPr id="155" name="Up Arrow 154"/>
                  <p:cNvSpPr/>
                  <p:nvPr/>
                </p:nvSpPr>
                <p:spPr>
                  <a:xfrm>
                    <a:off x="1389043" y="2533847"/>
                    <a:ext cx="45719" cy="80354"/>
                  </a:xfrm>
                  <a:prstGeom prst="upArrow">
                    <a:avLst/>
                  </a:prstGeom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6" name="Rectangle 155"/>
                  <p:cNvSpPr/>
                  <p:nvPr/>
                </p:nvSpPr>
                <p:spPr>
                  <a:xfrm>
                    <a:off x="913554" y="2678332"/>
                    <a:ext cx="991446" cy="422464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sz="12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OSA26</a:t>
                    </a:r>
                  </a:p>
                  <a:p>
                    <a:pPr algn="ctr"/>
                    <a:r>
                      <a:rPr lang="en-US" sz="12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omoter</a:t>
                    </a:r>
                    <a:endParaRPr lang="en-US" sz="1200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92" name="TextBox 91"/>
                <p:cNvSpPr txBox="1"/>
                <p:nvPr/>
              </p:nvSpPr>
              <p:spPr>
                <a:xfrm>
                  <a:off x="1764737" y="3631007"/>
                  <a:ext cx="199766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Knock-In ROSA26 Locus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93" name="Group 92"/>
                <p:cNvGrpSpPr/>
                <p:nvPr/>
              </p:nvGrpSpPr>
              <p:grpSpPr>
                <a:xfrm>
                  <a:off x="228600" y="3977343"/>
                  <a:ext cx="6472413" cy="673434"/>
                  <a:chOff x="213374" y="2911365"/>
                  <a:chExt cx="6472413" cy="673434"/>
                </a:xfrm>
              </p:grpSpPr>
              <p:grpSp>
                <p:nvGrpSpPr>
                  <p:cNvPr id="138" name="Group 137"/>
                  <p:cNvGrpSpPr/>
                  <p:nvPr/>
                </p:nvGrpSpPr>
                <p:grpSpPr>
                  <a:xfrm>
                    <a:off x="408299" y="2911365"/>
                    <a:ext cx="6013282" cy="673434"/>
                    <a:chOff x="463718" y="1633210"/>
                    <a:chExt cx="6013282" cy="673434"/>
                  </a:xfrm>
                </p:grpSpPr>
                <p:cxnSp>
                  <p:nvCxnSpPr>
                    <p:cNvPr id="141" name="Straight Connector 140"/>
                    <p:cNvCxnSpPr/>
                    <p:nvPr/>
                  </p:nvCxnSpPr>
                  <p:spPr>
                    <a:xfrm>
                      <a:off x="463718" y="1905000"/>
                      <a:ext cx="914400" cy="0"/>
                    </a:xfrm>
                    <a:prstGeom prst="line">
                      <a:avLst/>
                    </a:prstGeom>
                    <a:ln w="28575">
                      <a:solidFill>
                        <a:srgbClr val="0070C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42" name="Straight Connector 141"/>
                    <p:cNvCxnSpPr/>
                    <p:nvPr/>
                  </p:nvCxnSpPr>
                  <p:spPr>
                    <a:xfrm>
                      <a:off x="4038600" y="1907628"/>
                      <a:ext cx="2438400" cy="0"/>
                    </a:xfrm>
                    <a:prstGeom prst="line">
                      <a:avLst/>
                    </a:prstGeom>
                    <a:ln w="28575">
                      <a:solidFill>
                        <a:srgbClr val="FF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43" name="Rectangle 142"/>
                    <p:cNvSpPr/>
                    <p:nvPr/>
                  </p:nvSpPr>
                  <p:spPr>
                    <a:xfrm>
                      <a:off x="1378118" y="1633210"/>
                      <a:ext cx="2965282" cy="42419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cxnSp>
                  <p:nvCxnSpPr>
                    <p:cNvPr id="144" name="Straight Connector 143"/>
                    <p:cNvCxnSpPr/>
                    <p:nvPr/>
                  </p:nvCxnSpPr>
                  <p:spPr>
                    <a:xfrm>
                      <a:off x="3324557" y="1646345"/>
                      <a:ext cx="0" cy="42419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45" name="Isosceles Triangle 144"/>
                    <p:cNvSpPr/>
                    <p:nvPr/>
                  </p:nvSpPr>
                  <p:spPr>
                    <a:xfrm rot="16200000">
                      <a:off x="3173148" y="1883152"/>
                      <a:ext cx="152401" cy="141554"/>
                    </a:xfrm>
                    <a:prstGeom prst="triangle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6" name="Isosceles Triangle 145"/>
                    <p:cNvSpPr/>
                    <p:nvPr/>
                  </p:nvSpPr>
                  <p:spPr>
                    <a:xfrm rot="16200000">
                      <a:off x="1508641" y="1651769"/>
                      <a:ext cx="152401" cy="141554"/>
                    </a:xfrm>
                    <a:prstGeom prst="triangle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47" name="TextBox 146"/>
                    <p:cNvSpPr txBox="1"/>
                    <p:nvPr/>
                  </p:nvSpPr>
                  <p:spPr>
                    <a:xfrm>
                      <a:off x="1600200" y="1719590"/>
                      <a:ext cx="1693541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o-STOP2xSV40pA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8" name="TextBox 147"/>
                    <p:cNvSpPr txBox="1"/>
                    <p:nvPr/>
                  </p:nvSpPr>
                  <p:spPr>
                    <a:xfrm>
                      <a:off x="3228076" y="1648607"/>
                      <a:ext cx="997389" cy="4616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12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t6</a:t>
                      </a:r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FLAG</a:t>
                      </a:r>
                    </a:p>
                    <a:p>
                      <a:pPr algn="ctr"/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NA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149" name="Straight Connector 148"/>
                    <p:cNvCxnSpPr/>
                    <p:nvPr/>
                  </p:nvCxnSpPr>
                  <p:spPr>
                    <a:xfrm>
                      <a:off x="1503219" y="1633210"/>
                      <a:ext cx="0" cy="42419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0" name="Straight Connector 149"/>
                    <p:cNvCxnSpPr/>
                    <p:nvPr/>
                  </p:nvCxnSpPr>
                  <p:spPr>
                    <a:xfrm>
                      <a:off x="4144751" y="1636495"/>
                      <a:ext cx="0" cy="42419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1" name="TextBox 150"/>
                    <p:cNvSpPr txBox="1"/>
                    <p:nvPr/>
                  </p:nvSpPr>
                  <p:spPr>
                    <a:xfrm>
                      <a:off x="4096271" y="2029645"/>
                      <a:ext cx="73129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GHpA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2" name="TextBox 151"/>
                    <p:cNvSpPr txBox="1"/>
                    <p:nvPr/>
                  </p:nvSpPr>
                  <p:spPr>
                    <a:xfrm>
                      <a:off x="761164" y="1643390"/>
                      <a:ext cx="39786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53" name="TextBox 152"/>
                    <p:cNvSpPr txBox="1"/>
                    <p:nvPr/>
                  </p:nvSpPr>
                  <p:spPr>
                    <a:xfrm>
                      <a:off x="5066882" y="1643390"/>
                      <a:ext cx="38985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cxnSp>
                <p:nvCxnSpPr>
                  <p:cNvPr id="139" name="Straight Connector 138"/>
                  <p:cNvCxnSpPr/>
                  <p:nvPr/>
                </p:nvCxnSpPr>
                <p:spPr>
                  <a:xfrm>
                    <a:off x="213374" y="3184143"/>
                    <a:ext cx="22860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" name="Straight Connector 139"/>
                  <p:cNvCxnSpPr/>
                  <p:nvPr/>
                </p:nvCxnSpPr>
                <p:spPr>
                  <a:xfrm flipV="1">
                    <a:off x="6401768" y="3185659"/>
                    <a:ext cx="284019" cy="263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4" name="Group 93"/>
                <p:cNvGrpSpPr/>
                <p:nvPr/>
              </p:nvGrpSpPr>
              <p:grpSpPr>
                <a:xfrm>
                  <a:off x="381000" y="4423627"/>
                  <a:ext cx="5480131" cy="1664208"/>
                  <a:chOff x="362465" y="3070492"/>
                  <a:chExt cx="5480131" cy="1664208"/>
                </a:xfrm>
              </p:grpSpPr>
              <p:cxnSp>
                <p:nvCxnSpPr>
                  <p:cNvPr id="123" name="Straight Connector 122"/>
                  <p:cNvCxnSpPr/>
                  <p:nvPr/>
                </p:nvCxnSpPr>
                <p:spPr>
                  <a:xfrm flipH="1">
                    <a:off x="1434762" y="3070492"/>
                    <a:ext cx="6884" cy="663308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" name="Straight Connector 123"/>
                  <p:cNvCxnSpPr/>
                  <p:nvPr/>
                </p:nvCxnSpPr>
                <p:spPr>
                  <a:xfrm flipH="1">
                    <a:off x="3256100" y="3138036"/>
                    <a:ext cx="13038" cy="595764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" name="Straight Connector 124"/>
                  <p:cNvCxnSpPr/>
                  <p:nvPr/>
                </p:nvCxnSpPr>
                <p:spPr>
                  <a:xfrm>
                    <a:off x="1434762" y="3733800"/>
                    <a:ext cx="855053" cy="314325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  <a:prstDash val="dash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6" name="Straight Connector 125"/>
                  <p:cNvCxnSpPr/>
                  <p:nvPr/>
                </p:nvCxnSpPr>
                <p:spPr>
                  <a:xfrm flipV="1">
                    <a:off x="2388236" y="3733800"/>
                    <a:ext cx="880902" cy="314326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  <a:prstDash val="dashDot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7" name="TextBox 126"/>
                  <p:cNvSpPr txBox="1"/>
                  <p:nvPr/>
                </p:nvSpPr>
                <p:spPr>
                  <a:xfrm>
                    <a:off x="1488524" y="3348610"/>
                    <a:ext cx="1711876" cy="307777"/>
                  </a:xfrm>
                  <a:prstGeom prst="rect">
                    <a:avLst/>
                  </a:prstGeom>
                </p:spPr>
                <p:style>
                  <a:lnRef idx="2">
                    <a:schemeClr val="accent2"/>
                  </a:lnRef>
                  <a:fillRef idx="1">
                    <a:schemeClr val="lt1"/>
                  </a:fillRef>
                  <a:effectRef idx="0">
                    <a:schemeClr val="accent2"/>
                  </a:effectRef>
                  <a:fontRef idx="minor">
                    <a:schemeClr val="dk1"/>
                  </a:fontRef>
                </p:style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400" b="1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yl1</a:t>
                    </a:r>
                    <a:r>
                      <a:rPr lang="en-US" sz="1400" b="1" baseline="30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tm1(</a:t>
                    </a:r>
                    <a:r>
                      <a:rPr lang="en-US" sz="1400" b="1" baseline="300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re</a:t>
                    </a:r>
                    <a:r>
                      <a:rPr lang="en-US" sz="1400" b="1" baseline="30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r>
                      <a:rPr lang="en-US" sz="1400" b="1" baseline="300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jb</a:t>
                    </a:r>
                    <a:r>
                      <a:rPr lang="en-US" sz="14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/J</a:t>
                    </a:r>
                    <a:endPara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8" name="Isosceles Triangle 127"/>
                  <p:cNvSpPr/>
                  <p:nvPr/>
                </p:nvSpPr>
                <p:spPr>
                  <a:xfrm rot="16200000">
                    <a:off x="2185840" y="4196424"/>
                    <a:ext cx="152401" cy="141554"/>
                  </a:xfrm>
                  <a:prstGeom prst="triangle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9" name="Rectangle 128"/>
                  <p:cNvSpPr/>
                  <p:nvPr/>
                </p:nvSpPr>
                <p:spPr>
                  <a:xfrm>
                    <a:off x="2419244" y="4086226"/>
                    <a:ext cx="818885" cy="381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0" name="TextBox 129"/>
                  <p:cNvSpPr txBox="1"/>
                  <p:nvPr/>
                </p:nvSpPr>
                <p:spPr>
                  <a:xfrm>
                    <a:off x="2315003" y="4061282"/>
                    <a:ext cx="1016358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i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rt6</a:t>
                    </a:r>
                    <a:r>
                      <a:rPr lang="en-US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FLAG</a:t>
                    </a:r>
                  </a:p>
                  <a:p>
                    <a:pPr algn="ctr"/>
                    <a:r>
                      <a:rPr lang="en-US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NA</a:t>
                    </a:r>
                    <a:endPara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Rectangle 130"/>
                  <p:cNvSpPr/>
                  <p:nvPr/>
                </p:nvSpPr>
                <p:spPr>
                  <a:xfrm>
                    <a:off x="1276865" y="4076701"/>
                    <a:ext cx="818885" cy="381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1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2" name="TextBox 131"/>
                  <p:cNvSpPr txBox="1"/>
                  <p:nvPr/>
                </p:nvSpPr>
                <p:spPr>
                  <a:xfrm>
                    <a:off x="1183199" y="4041577"/>
                    <a:ext cx="976640" cy="46166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OSA26 Promoter</a:t>
                    </a:r>
                    <a:endPara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33" name="Straight Connector 132"/>
                  <p:cNvCxnSpPr/>
                  <p:nvPr/>
                </p:nvCxnSpPr>
                <p:spPr>
                  <a:xfrm>
                    <a:off x="2086297" y="4267201"/>
                    <a:ext cx="323494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4" name="Rectangle 133"/>
                  <p:cNvSpPr/>
                  <p:nvPr/>
                </p:nvSpPr>
                <p:spPr>
                  <a:xfrm>
                    <a:off x="3228975" y="4086226"/>
                    <a:ext cx="184746" cy="381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5" name="TextBox 134"/>
                  <p:cNvSpPr txBox="1"/>
                  <p:nvPr/>
                </p:nvSpPr>
                <p:spPr>
                  <a:xfrm>
                    <a:off x="3118058" y="4457701"/>
                    <a:ext cx="73129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GHpA</a:t>
                    </a:r>
                    <a:endPara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36" name="Straight Connector 135"/>
                  <p:cNvCxnSpPr/>
                  <p:nvPr/>
                </p:nvCxnSpPr>
                <p:spPr>
                  <a:xfrm>
                    <a:off x="3404196" y="4267201"/>
                    <a:ext cx="2438400" cy="0"/>
                  </a:xfrm>
                  <a:prstGeom prst="line">
                    <a:avLst/>
                  </a:prstGeom>
                  <a:ln w="2857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7" name="Straight Connector 136"/>
                  <p:cNvCxnSpPr/>
                  <p:nvPr/>
                </p:nvCxnSpPr>
                <p:spPr>
                  <a:xfrm>
                    <a:off x="362465" y="4278531"/>
                    <a:ext cx="914400" cy="0"/>
                  </a:xfrm>
                  <a:prstGeom prst="line">
                    <a:avLst/>
                  </a:prstGeom>
                  <a:ln w="28575">
                    <a:solidFill>
                      <a:srgbClr val="0070C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5" name="Up Arrow 94"/>
                <p:cNvSpPr/>
                <p:nvPr/>
              </p:nvSpPr>
              <p:spPr>
                <a:xfrm>
                  <a:off x="1356187" y="4450995"/>
                  <a:ext cx="45719" cy="80353"/>
                </a:xfrm>
                <a:prstGeom prst="upArrow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96" name="Group 95"/>
                <p:cNvGrpSpPr/>
                <p:nvPr/>
              </p:nvGrpSpPr>
              <p:grpSpPr>
                <a:xfrm>
                  <a:off x="402687" y="6754423"/>
                  <a:ext cx="5435368" cy="286221"/>
                  <a:chOff x="355832" y="5885088"/>
                  <a:chExt cx="5435368" cy="286221"/>
                </a:xfrm>
              </p:grpSpPr>
              <p:grpSp>
                <p:nvGrpSpPr>
                  <p:cNvPr id="110" name="Group 109"/>
                  <p:cNvGrpSpPr/>
                  <p:nvPr/>
                </p:nvGrpSpPr>
                <p:grpSpPr>
                  <a:xfrm>
                    <a:off x="2106299" y="5885088"/>
                    <a:ext cx="3684901" cy="286221"/>
                    <a:chOff x="347332" y="4157990"/>
                    <a:chExt cx="3684901" cy="286221"/>
                  </a:xfrm>
                </p:grpSpPr>
                <p:grpSp>
                  <p:nvGrpSpPr>
                    <p:cNvPr id="114" name="Group 113"/>
                    <p:cNvGrpSpPr/>
                    <p:nvPr/>
                  </p:nvGrpSpPr>
                  <p:grpSpPr>
                    <a:xfrm>
                      <a:off x="347332" y="4182601"/>
                      <a:ext cx="1396714" cy="261610"/>
                      <a:chOff x="347332" y="4182601"/>
                      <a:chExt cx="1396714" cy="261610"/>
                    </a:xfrm>
                  </p:grpSpPr>
                  <p:cxnSp>
                    <p:nvCxnSpPr>
                      <p:cNvPr id="121" name="Straight Connector 120"/>
                      <p:cNvCxnSpPr/>
                      <p:nvPr/>
                    </p:nvCxnSpPr>
                    <p:spPr>
                      <a:xfrm>
                        <a:off x="1471858" y="4319547"/>
                        <a:ext cx="272188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0070C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2" name="TextBox 121"/>
                      <p:cNvSpPr txBox="1"/>
                      <p:nvPr/>
                    </p:nvSpPr>
                    <p:spPr>
                      <a:xfrm>
                        <a:off x="347332" y="4182601"/>
                        <a:ext cx="1210588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hort Arm(SA):</a:t>
                        </a:r>
                        <a:endPara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15" name="Group 114"/>
                    <p:cNvGrpSpPr/>
                    <p:nvPr/>
                  </p:nvGrpSpPr>
                  <p:grpSpPr>
                    <a:xfrm>
                      <a:off x="2597819" y="4157990"/>
                      <a:ext cx="1434414" cy="261610"/>
                      <a:chOff x="2597819" y="4157990"/>
                      <a:chExt cx="1434414" cy="261610"/>
                    </a:xfrm>
                  </p:grpSpPr>
                  <p:cxnSp>
                    <p:nvCxnSpPr>
                      <p:cNvPr id="119" name="Straight Connector 118"/>
                      <p:cNvCxnSpPr/>
                      <p:nvPr/>
                    </p:nvCxnSpPr>
                    <p:spPr>
                      <a:xfrm>
                        <a:off x="3760045" y="4296901"/>
                        <a:ext cx="272188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FF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0" name="TextBox 119"/>
                      <p:cNvSpPr txBox="1"/>
                      <p:nvPr/>
                    </p:nvSpPr>
                    <p:spPr>
                      <a:xfrm>
                        <a:off x="2597819" y="4157990"/>
                        <a:ext cx="1218603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ong Arm (LA):</a:t>
                        </a:r>
                        <a:endPara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16" name="Group 115"/>
                    <p:cNvGrpSpPr/>
                    <p:nvPr/>
                  </p:nvGrpSpPr>
                  <p:grpSpPr>
                    <a:xfrm>
                      <a:off x="1813079" y="4157990"/>
                      <a:ext cx="589064" cy="261610"/>
                      <a:chOff x="1062530" y="4097565"/>
                      <a:chExt cx="589064" cy="261610"/>
                    </a:xfrm>
                  </p:grpSpPr>
                  <p:sp>
                    <p:nvSpPr>
                      <p:cNvPr id="117" name="Isosceles Triangle 116"/>
                      <p:cNvSpPr/>
                      <p:nvPr/>
                    </p:nvSpPr>
                    <p:spPr>
                      <a:xfrm rot="16200000">
                        <a:off x="1556343" y="4203831"/>
                        <a:ext cx="112776" cy="77726"/>
                      </a:xfrm>
                      <a:prstGeom prst="triangle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  <p:sp>
                    <p:nvSpPr>
                      <p:cNvPr id="118" name="TextBox 117"/>
                      <p:cNvSpPr txBox="1"/>
                      <p:nvPr/>
                    </p:nvSpPr>
                    <p:spPr>
                      <a:xfrm>
                        <a:off x="1062530" y="4097565"/>
                        <a:ext cx="577402" cy="2616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100" b="1" dirty="0" err="1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oxP</a:t>
                        </a:r>
                        <a:r>
                          <a:rPr lang="en-US" sz="1100" b="1" dirty="0" smtClean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:</a:t>
                        </a:r>
                        <a:endPara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111" name="Group 110"/>
                  <p:cNvGrpSpPr/>
                  <p:nvPr/>
                </p:nvGrpSpPr>
                <p:grpSpPr>
                  <a:xfrm>
                    <a:off x="355832" y="5906847"/>
                    <a:ext cx="1618666" cy="261610"/>
                    <a:chOff x="355832" y="5906847"/>
                    <a:chExt cx="1618666" cy="261610"/>
                  </a:xfrm>
                </p:grpSpPr>
                <p:cxnSp>
                  <p:nvCxnSpPr>
                    <p:cNvPr id="112" name="Straight Connector 111"/>
                    <p:cNvCxnSpPr/>
                    <p:nvPr/>
                  </p:nvCxnSpPr>
                  <p:spPr>
                    <a:xfrm>
                      <a:off x="1764227" y="6054141"/>
                      <a:ext cx="210271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13" name="TextBox 112"/>
                    <p:cNvSpPr txBox="1"/>
                    <p:nvPr/>
                  </p:nvSpPr>
                  <p:spPr>
                    <a:xfrm>
                      <a:off x="355832" y="5906847"/>
                      <a:ext cx="1452642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anking Genome :</a:t>
                      </a:r>
                    </a:p>
                  </p:txBody>
                </p:sp>
              </p:grpSp>
            </p:grpSp>
            <p:grpSp>
              <p:nvGrpSpPr>
                <p:cNvPr id="97" name="Group 96"/>
                <p:cNvGrpSpPr/>
                <p:nvPr/>
              </p:nvGrpSpPr>
              <p:grpSpPr>
                <a:xfrm>
                  <a:off x="548626" y="990600"/>
                  <a:ext cx="5181600" cy="766708"/>
                  <a:chOff x="533400" y="713065"/>
                  <a:chExt cx="5181600" cy="766708"/>
                </a:xfrm>
              </p:grpSpPr>
              <p:grpSp>
                <p:nvGrpSpPr>
                  <p:cNvPr id="101" name="Group 100"/>
                  <p:cNvGrpSpPr/>
                  <p:nvPr/>
                </p:nvGrpSpPr>
                <p:grpSpPr>
                  <a:xfrm>
                    <a:off x="533400" y="713065"/>
                    <a:ext cx="5181600" cy="353735"/>
                    <a:chOff x="533400" y="713065"/>
                    <a:chExt cx="5181600" cy="353735"/>
                  </a:xfrm>
                </p:grpSpPr>
                <p:sp>
                  <p:nvSpPr>
                    <p:cNvPr id="104" name="TextBox 103"/>
                    <p:cNvSpPr txBox="1"/>
                    <p:nvPr/>
                  </p:nvSpPr>
                  <p:spPr>
                    <a:xfrm>
                      <a:off x="2168344" y="713065"/>
                      <a:ext cx="157883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ROSA26 Locus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05" name="Group 104"/>
                    <p:cNvGrpSpPr/>
                    <p:nvPr/>
                  </p:nvGrpSpPr>
                  <p:grpSpPr>
                    <a:xfrm>
                      <a:off x="533400" y="1059903"/>
                      <a:ext cx="5181600" cy="6897"/>
                      <a:chOff x="533400" y="1059903"/>
                      <a:chExt cx="5181600" cy="6897"/>
                    </a:xfrm>
                  </p:grpSpPr>
                  <p:cxnSp>
                    <p:nvCxnSpPr>
                      <p:cNvPr id="106" name="Straight Connector 105"/>
                      <p:cNvCxnSpPr/>
                      <p:nvPr/>
                    </p:nvCxnSpPr>
                    <p:spPr>
                      <a:xfrm>
                        <a:off x="533400" y="1066800"/>
                        <a:ext cx="914400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7" name="Straight Connector 106"/>
                      <p:cNvCxnSpPr/>
                      <p:nvPr/>
                    </p:nvCxnSpPr>
                    <p:spPr>
                      <a:xfrm>
                        <a:off x="1447800" y="1066800"/>
                        <a:ext cx="914400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0070C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8" name="Straight Connector 107"/>
                      <p:cNvCxnSpPr/>
                      <p:nvPr/>
                    </p:nvCxnSpPr>
                    <p:spPr>
                      <a:xfrm>
                        <a:off x="2362200" y="1059903"/>
                        <a:ext cx="2438400" cy="0"/>
                      </a:xfrm>
                      <a:prstGeom prst="line">
                        <a:avLst/>
                      </a:prstGeom>
                      <a:ln w="28575">
                        <a:solidFill>
                          <a:srgbClr val="FF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09" name="Straight Connector 108"/>
                      <p:cNvCxnSpPr/>
                      <p:nvPr/>
                    </p:nvCxnSpPr>
                    <p:spPr>
                      <a:xfrm>
                        <a:off x="4800600" y="1059903"/>
                        <a:ext cx="914400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cxnSp>
                <p:nvCxnSpPr>
                  <p:cNvPr id="102" name="Straight Arrow Connector 101"/>
                  <p:cNvCxnSpPr/>
                  <p:nvPr/>
                </p:nvCxnSpPr>
                <p:spPr>
                  <a:xfrm flipV="1">
                    <a:off x="2362199" y="1072179"/>
                    <a:ext cx="0" cy="15502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3" name="TextBox 102"/>
                  <p:cNvSpPr txBox="1"/>
                  <p:nvPr/>
                </p:nvSpPr>
                <p:spPr>
                  <a:xfrm>
                    <a:off x="2040364" y="1218163"/>
                    <a:ext cx="700833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tron 1</a:t>
                    </a:r>
                    <a:endPara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98" name="TextBox 97"/>
                <p:cNvSpPr txBox="1"/>
                <p:nvPr/>
              </p:nvSpPr>
              <p:spPr>
                <a:xfrm>
                  <a:off x="2299854" y="4363476"/>
                  <a:ext cx="345085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2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X</a:t>
                  </a:r>
                  <a:endParaRPr lang="en-US" sz="2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>
                  <a:off x="875521" y="6375406"/>
                  <a:ext cx="444865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keletal Muscle-specific over-expression of SIRT6</a:t>
                  </a:r>
                  <a:endParaRPr 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0" name="Down Arrow 99"/>
                <p:cNvSpPr/>
                <p:nvPr/>
              </p:nvSpPr>
              <p:spPr>
                <a:xfrm>
                  <a:off x="2858492" y="5941641"/>
                  <a:ext cx="61017" cy="371385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86" name="TextBox 85"/>
              <p:cNvSpPr txBox="1"/>
              <p:nvPr/>
            </p:nvSpPr>
            <p:spPr>
              <a:xfrm>
                <a:off x="120543" y="366834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150198" y="2998900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186398" y="4599460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129360" y="1374063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3193009" y="4105481"/>
                <a:ext cx="1781215" cy="4685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yosin Light Chain-</a:t>
                </a:r>
                <a:r>
                  <a:rPr lang="en-US" sz="12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re</a:t>
                </a:r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Recombinase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2" name="TextBox 171"/>
            <p:cNvSpPr txBox="1"/>
            <p:nvPr/>
          </p:nvSpPr>
          <p:spPr>
            <a:xfrm>
              <a:off x="107719" y="79439"/>
              <a:ext cx="338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75066" y="6669517"/>
              <a:ext cx="338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8" name="Group 197"/>
            <p:cNvGrpSpPr/>
            <p:nvPr/>
          </p:nvGrpSpPr>
          <p:grpSpPr>
            <a:xfrm>
              <a:off x="487962" y="6946516"/>
              <a:ext cx="6508028" cy="1600999"/>
              <a:chOff x="73327" y="7083544"/>
              <a:chExt cx="6508028" cy="1600999"/>
            </a:xfrm>
          </p:grpSpPr>
          <p:grpSp>
            <p:nvGrpSpPr>
              <p:cNvPr id="196" name="Group 195"/>
              <p:cNvGrpSpPr/>
              <p:nvPr/>
            </p:nvGrpSpPr>
            <p:grpSpPr>
              <a:xfrm>
                <a:off x="190775" y="7438768"/>
                <a:ext cx="4805802" cy="1245775"/>
                <a:chOff x="190775" y="7438768"/>
                <a:chExt cx="4805802" cy="1245775"/>
              </a:xfrm>
            </p:grpSpPr>
            <p:pic>
              <p:nvPicPr>
                <p:cNvPr id="184" name="Picture 183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71" t="19011" r="1212" b="69581"/>
                <a:stretch/>
              </p:blipFill>
              <p:spPr>
                <a:xfrm>
                  <a:off x="192232" y="7438768"/>
                  <a:ext cx="4795780" cy="496359"/>
                </a:xfrm>
                <a:prstGeom prst="rect">
                  <a:avLst/>
                </a:prstGeom>
              </p:spPr>
            </p:pic>
            <p:pic>
              <p:nvPicPr>
                <p:cNvPr id="185" name="Picture 184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74" t="16926" r="1607" b="66526"/>
                <a:stretch/>
              </p:blipFill>
              <p:spPr>
                <a:xfrm>
                  <a:off x="190775" y="7954766"/>
                  <a:ext cx="4805802" cy="729777"/>
                </a:xfrm>
                <a:prstGeom prst="rect">
                  <a:avLst/>
                </a:prstGeom>
              </p:spPr>
            </p:pic>
          </p:grpSp>
          <p:grpSp>
            <p:nvGrpSpPr>
              <p:cNvPr id="197" name="Group 196"/>
              <p:cNvGrpSpPr/>
              <p:nvPr/>
            </p:nvGrpSpPr>
            <p:grpSpPr>
              <a:xfrm>
                <a:off x="73327" y="7083544"/>
                <a:ext cx="6508028" cy="1564504"/>
                <a:chOff x="73327" y="7083544"/>
                <a:chExt cx="6508028" cy="1564504"/>
              </a:xfrm>
            </p:grpSpPr>
            <p:sp>
              <p:nvSpPr>
                <p:cNvPr id="176" name="TextBox 175"/>
                <p:cNvSpPr txBox="1"/>
                <p:nvPr/>
              </p:nvSpPr>
              <p:spPr>
                <a:xfrm>
                  <a:off x="4455643" y="8001717"/>
                  <a:ext cx="2125712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yl1-Cre</a:t>
                  </a:r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WT:200 </a:t>
                  </a:r>
                  <a:r>
                    <a:rPr lang="en-US" sz="12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p</a:t>
                  </a:r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en-US" sz="12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ut</a:t>
                  </a:r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280bp)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TextBox 176"/>
                <p:cNvSpPr txBox="1"/>
                <p:nvPr/>
              </p:nvSpPr>
              <p:spPr>
                <a:xfrm>
                  <a:off x="73327" y="7249682"/>
                  <a:ext cx="44901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r>
                    <a:rPr lang="en-US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8" name="TextBox 177"/>
                <p:cNvSpPr txBox="1"/>
                <p:nvPr/>
              </p:nvSpPr>
              <p:spPr>
                <a:xfrm>
                  <a:off x="357859" y="7249682"/>
                  <a:ext cx="29206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9" name="TextBox 178"/>
                <p:cNvSpPr txBox="1"/>
                <p:nvPr/>
              </p:nvSpPr>
              <p:spPr>
                <a:xfrm>
                  <a:off x="4610696" y="7257803"/>
                  <a:ext cx="45957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+CN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0" name="TextBox 179"/>
                <p:cNvSpPr txBox="1"/>
                <p:nvPr/>
              </p:nvSpPr>
              <p:spPr>
                <a:xfrm>
                  <a:off x="4613858" y="7487986"/>
                  <a:ext cx="1745064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IRT6-FLAG</a:t>
                  </a:r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450bp)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8" name="TextBox 187"/>
                <p:cNvSpPr txBox="1"/>
                <p:nvPr/>
              </p:nvSpPr>
              <p:spPr>
                <a:xfrm>
                  <a:off x="1629553" y="7083544"/>
                  <a:ext cx="212571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Tail DNA PCR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0" name="Straight Connector 189"/>
                <p:cNvCxnSpPr/>
                <p:nvPr/>
              </p:nvCxnSpPr>
              <p:spPr>
                <a:xfrm>
                  <a:off x="751733" y="7298899"/>
                  <a:ext cx="399273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99" name="TextBox 198"/>
            <p:cNvSpPr txBox="1"/>
            <p:nvPr/>
          </p:nvSpPr>
          <p:spPr>
            <a:xfrm>
              <a:off x="2787185" y="8729379"/>
              <a:ext cx="8867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S1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03019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</TotalTime>
  <Words>94</Words>
  <Application>Microsoft Office PowerPoint</Application>
  <PresentationFormat>Letter Paper (8.5x11 in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University of Chicag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ant, Sadhana [BSD] - SUR</dc:creator>
  <cp:lastModifiedBy>Samant, Sadhana [BSD] - SUR</cp:lastModifiedBy>
  <cp:revision>13</cp:revision>
  <dcterms:created xsi:type="dcterms:W3CDTF">2020-07-20T18:41:56Z</dcterms:created>
  <dcterms:modified xsi:type="dcterms:W3CDTF">2020-08-13T15:42:28Z</dcterms:modified>
</cp:coreProperties>
</file>